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21488400" cy="22126575"/>
  <p:notesSz cx="6858000" cy="9144000"/>
  <p:defaultTextStyle>
    <a:defPPr>
      <a:defRPr lang="en-US"/>
    </a:defPPr>
    <a:lvl1pPr marL="0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1pPr>
    <a:lvl2pPr marL="508544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2pPr>
    <a:lvl3pPr marL="1017087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3pPr>
    <a:lvl4pPr marL="1525631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4pPr>
    <a:lvl5pPr marL="2034174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5pPr>
    <a:lvl6pPr marL="2542718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6pPr>
    <a:lvl7pPr marL="3051261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7pPr>
    <a:lvl8pPr marL="3559805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8pPr>
    <a:lvl9pPr marL="4068348" algn="l" defTabSz="508544" rtl="0" eaLnBrk="1" latinLnBrk="0" hangingPunct="1">
      <a:defRPr sz="200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123" userDrawn="1">
          <p15:clr>
            <a:srgbClr val="A4A3A4"/>
          </p15:clr>
        </p15:guide>
        <p15:guide id="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282"/>
    <p:restoredTop sz="99783" autoAdjust="0"/>
  </p:normalViewPr>
  <p:slideViewPr>
    <p:cSldViewPr snapToGrid="0" snapToObjects="1" showGuides="1">
      <p:cViewPr>
        <p:scale>
          <a:sx n="104" d="100"/>
          <a:sy n="104" d="100"/>
        </p:scale>
        <p:origin x="136" y="-7336"/>
      </p:cViewPr>
      <p:guideLst>
        <p:guide orient="horz" pos="7123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051B62-D56B-2A49-B75E-4CDC46286272}" type="datetimeFigureOut">
              <a:rPr lang="en-US" smtClean="0"/>
              <a:t>4/1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1988" y="1143000"/>
            <a:ext cx="2994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841B69-ED92-284F-8C12-6C8D26C24E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412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1pPr>
    <a:lvl2pPr marL="508544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2pPr>
    <a:lvl3pPr marL="1017087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3pPr>
    <a:lvl4pPr marL="1525631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4pPr>
    <a:lvl5pPr marL="2034174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5pPr>
    <a:lvl6pPr marL="2542718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6pPr>
    <a:lvl7pPr marL="3051261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7pPr>
    <a:lvl8pPr marL="3559805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8pPr>
    <a:lvl9pPr marL="4068348" algn="l" defTabSz="1017087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1634" y="6873610"/>
            <a:ext cx="18265141" cy="474287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223270" y="12538398"/>
            <a:ext cx="15041881" cy="565457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81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639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459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1279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4099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6919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9739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2558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790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398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579099" y="886109"/>
            <a:ext cx="4834890" cy="1887929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74426" y="886109"/>
            <a:ext cx="14146530" cy="1887929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402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24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97438" y="14218402"/>
            <a:ext cx="18265141" cy="4394584"/>
          </a:xfrm>
        </p:spPr>
        <p:txBody>
          <a:bodyPr anchor="t"/>
          <a:lstStyle>
            <a:lvl1pPr algn="l">
              <a:defRPr sz="2467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97438" y="9378218"/>
            <a:ext cx="18265141" cy="4840188"/>
          </a:xfrm>
        </p:spPr>
        <p:txBody>
          <a:bodyPr anchor="b"/>
          <a:lstStyle>
            <a:lvl1pPr marL="0" indent="0">
              <a:buNone/>
              <a:defRPr sz="1234">
                <a:solidFill>
                  <a:schemeClr val="tx1">
                    <a:tint val="75000"/>
                  </a:schemeClr>
                </a:solidFill>
              </a:defRPr>
            </a:lvl1pPr>
            <a:lvl2pPr marL="281988" indent="0">
              <a:buNone/>
              <a:defRPr sz="1110">
                <a:solidFill>
                  <a:schemeClr val="tx1">
                    <a:tint val="75000"/>
                  </a:schemeClr>
                </a:solidFill>
              </a:defRPr>
            </a:lvl2pPr>
            <a:lvl3pPr marL="563975" indent="0">
              <a:buNone/>
              <a:defRPr sz="987">
                <a:solidFill>
                  <a:schemeClr val="tx1">
                    <a:tint val="75000"/>
                  </a:schemeClr>
                </a:solidFill>
              </a:defRPr>
            </a:lvl3pPr>
            <a:lvl4pPr marL="845961" indent="0">
              <a:buNone/>
              <a:defRPr sz="864">
                <a:solidFill>
                  <a:schemeClr val="tx1">
                    <a:tint val="75000"/>
                  </a:schemeClr>
                </a:solidFill>
              </a:defRPr>
            </a:lvl4pPr>
            <a:lvl5pPr marL="1127948" indent="0">
              <a:buNone/>
              <a:defRPr sz="864">
                <a:solidFill>
                  <a:schemeClr val="tx1">
                    <a:tint val="75000"/>
                  </a:schemeClr>
                </a:solidFill>
              </a:defRPr>
            </a:lvl5pPr>
            <a:lvl6pPr marL="1409935" indent="0">
              <a:buNone/>
              <a:defRPr sz="864">
                <a:solidFill>
                  <a:schemeClr val="tx1">
                    <a:tint val="75000"/>
                  </a:schemeClr>
                </a:solidFill>
              </a:defRPr>
            </a:lvl6pPr>
            <a:lvl7pPr marL="1691921" indent="0">
              <a:buNone/>
              <a:defRPr sz="864">
                <a:solidFill>
                  <a:schemeClr val="tx1">
                    <a:tint val="75000"/>
                  </a:schemeClr>
                </a:solidFill>
              </a:defRPr>
            </a:lvl7pPr>
            <a:lvl8pPr marL="1973908" indent="0">
              <a:buNone/>
              <a:defRPr sz="864">
                <a:solidFill>
                  <a:schemeClr val="tx1">
                    <a:tint val="75000"/>
                  </a:schemeClr>
                </a:solidFill>
              </a:defRPr>
            </a:lvl8pPr>
            <a:lvl9pPr marL="2255896" indent="0">
              <a:buNone/>
              <a:defRPr sz="8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179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74428" y="5162889"/>
            <a:ext cx="9490711" cy="14602515"/>
          </a:xfrm>
        </p:spPr>
        <p:txBody>
          <a:bodyPr/>
          <a:lstStyle>
            <a:lvl1pPr>
              <a:defRPr sz="1727"/>
            </a:lvl1pPr>
            <a:lvl2pPr>
              <a:defRPr sz="1480"/>
            </a:lvl2pPr>
            <a:lvl3pPr>
              <a:defRPr sz="1234"/>
            </a:lvl3pPr>
            <a:lvl4pPr>
              <a:defRPr sz="1110"/>
            </a:lvl4pPr>
            <a:lvl5pPr>
              <a:defRPr sz="1110"/>
            </a:lvl5pPr>
            <a:lvl6pPr>
              <a:defRPr sz="1110"/>
            </a:lvl6pPr>
            <a:lvl7pPr>
              <a:defRPr sz="1110"/>
            </a:lvl7pPr>
            <a:lvl8pPr>
              <a:defRPr sz="1110"/>
            </a:lvl8pPr>
            <a:lvl9pPr>
              <a:defRPr sz="111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23279" y="5162889"/>
            <a:ext cx="9490711" cy="14602515"/>
          </a:xfrm>
        </p:spPr>
        <p:txBody>
          <a:bodyPr/>
          <a:lstStyle>
            <a:lvl1pPr>
              <a:defRPr sz="1727"/>
            </a:lvl1pPr>
            <a:lvl2pPr>
              <a:defRPr sz="1480"/>
            </a:lvl2pPr>
            <a:lvl3pPr>
              <a:defRPr sz="1234"/>
            </a:lvl3pPr>
            <a:lvl4pPr>
              <a:defRPr sz="1110"/>
            </a:lvl4pPr>
            <a:lvl5pPr>
              <a:defRPr sz="1110"/>
            </a:lvl5pPr>
            <a:lvl6pPr>
              <a:defRPr sz="1110"/>
            </a:lvl6pPr>
            <a:lvl7pPr>
              <a:defRPr sz="1110"/>
            </a:lvl7pPr>
            <a:lvl8pPr>
              <a:defRPr sz="1110"/>
            </a:lvl8pPr>
            <a:lvl9pPr>
              <a:defRPr sz="111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798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4429" y="4952889"/>
            <a:ext cx="9494438" cy="2064120"/>
          </a:xfrm>
        </p:spPr>
        <p:txBody>
          <a:bodyPr anchor="b"/>
          <a:lstStyle>
            <a:lvl1pPr marL="0" indent="0">
              <a:buNone/>
              <a:defRPr sz="1480" b="1"/>
            </a:lvl1pPr>
            <a:lvl2pPr marL="281988" indent="0">
              <a:buNone/>
              <a:defRPr sz="1234" b="1"/>
            </a:lvl2pPr>
            <a:lvl3pPr marL="563975" indent="0">
              <a:buNone/>
              <a:defRPr sz="1110" b="1"/>
            </a:lvl3pPr>
            <a:lvl4pPr marL="845961" indent="0">
              <a:buNone/>
              <a:defRPr sz="987" b="1"/>
            </a:lvl4pPr>
            <a:lvl5pPr marL="1127948" indent="0">
              <a:buNone/>
              <a:defRPr sz="987" b="1"/>
            </a:lvl5pPr>
            <a:lvl6pPr marL="1409935" indent="0">
              <a:buNone/>
              <a:defRPr sz="987" b="1"/>
            </a:lvl6pPr>
            <a:lvl7pPr marL="1691921" indent="0">
              <a:buNone/>
              <a:defRPr sz="987" b="1"/>
            </a:lvl7pPr>
            <a:lvl8pPr marL="1973908" indent="0">
              <a:buNone/>
              <a:defRPr sz="987" b="1"/>
            </a:lvl8pPr>
            <a:lvl9pPr marL="2255896" indent="0">
              <a:buNone/>
              <a:defRPr sz="98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4429" y="7017005"/>
            <a:ext cx="9494438" cy="12748392"/>
          </a:xfrm>
        </p:spPr>
        <p:txBody>
          <a:bodyPr/>
          <a:lstStyle>
            <a:lvl1pPr>
              <a:defRPr sz="1480"/>
            </a:lvl1pPr>
            <a:lvl2pPr>
              <a:defRPr sz="1234"/>
            </a:lvl2pPr>
            <a:lvl3pPr>
              <a:defRPr sz="1110"/>
            </a:lvl3pPr>
            <a:lvl4pPr>
              <a:defRPr sz="987"/>
            </a:lvl4pPr>
            <a:lvl5pPr>
              <a:defRPr sz="987"/>
            </a:lvl5pPr>
            <a:lvl6pPr>
              <a:defRPr sz="987"/>
            </a:lvl6pPr>
            <a:lvl7pPr>
              <a:defRPr sz="987"/>
            </a:lvl7pPr>
            <a:lvl8pPr>
              <a:defRPr sz="987"/>
            </a:lvl8pPr>
            <a:lvl9pPr>
              <a:defRPr sz="98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15833" y="4952889"/>
            <a:ext cx="9498171" cy="2064120"/>
          </a:xfrm>
        </p:spPr>
        <p:txBody>
          <a:bodyPr anchor="b"/>
          <a:lstStyle>
            <a:lvl1pPr marL="0" indent="0">
              <a:buNone/>
              <a:defRPr sz="1480" b="1"/>
            </a:lvl1pPr>
            <a:lvl2pPr marL="281988" indent="0">
              <a:buNone/>
              <a:defRPr sz="1234" b="1"/>
            </a:lvl2pPr>
            <a:lvl3pPr marL="563975" indent="0">
              <a:buNone/>
              <a:defRPr sz="1110" b="1"/>
            </a:lvl3pPr>
            <a:lvl4pPr marL="845961" indent="0">
              <a:buNone/>
              <a:defRPr sz="987" b="1"/>
            </a:lvl4pPr>
            <a:lvl5pPr marL="1127948" indent="0">
              <a:buNone/>
              <a:defRPr sz="987" b="1"/>
            </a:lvl5pPr>
            <a:lvl6pPr marL="1409935" indent="0">
              <a:buNone/>
              <a:defRPr sz="987" b="1"/>
            </a:lvl6pPr>
            <a:lvl7pPr marL="1691921" indent="0">
              <a:buNone/>
              <a:defRPr sz="987" b="1"/>
            </a:lvl7pPr>
            <a:lvl8pPr marL="1973908" indent="0">
              <a:buNone/>
              <a:defRPr sz="987" b="1"/>
            </a:lvl8pPr>
            <a:lvl9pPr marL="2255896" indent="0">
              <a:buNone/>
              <a:defRPr sz="98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15833" y="7017005"/>
            <a:ext cx="9498171" cy="12748392"/>
          </a:xfrm>
        </p:spPr>
        <p:txBody>
          <a:bodyPr/>
          <a:lstStyle>
            <a:lvl1pPr>
              <a:defRPr sz="1480"/>
            </a:lvl1pPr>
            <a:lvl2pPr>
              <a:defRPr sz="1234"/>
            </a:lvl2pPr>
            <a:lvl3pPr>
              <a:defRPr sz="1110"/>
            </a:lvl3pPr>
            <a:lvl4pPr>
              <a:defRPr sz="987"/>
            </a:lvl4pPr>
            <a:lvl5pPr>
              <a:defRPr sz="987"/>
            </a:lvl5pPr>
            <a:lvl6pPr>
              <a:defRPr sz="987"/>
            </a:lvl6pPr>
            <a:lvl7pPr>
              <a:defRPr sz="987"/>
            </a:lvl7pPr>
            <a:lvl8pPr>
              <a:defRPr sz="987"/>
            </a:lvl8pPr>
            <a:lvl9pPr>
              <a:defRPr sz="98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941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412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671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4441" y="880969"/>
            <a:ext cx="7069537" cy="3749224"/>
          </a:xfrm>
        </p:spPr>
        <p:txBody>
          <a:bodyPr anchor="b"/>
          <a:lstStyle>
            <a:lvl1pPr algn="l">
              <a:defRPr sz="12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401373" y="880998"/>
            <a:ext cx="12012613" cy="18884419"/>
          </a:xfrm>
        </p:spPr>
        <p:txBody>
          <a:bodyPr/>
          <a:lstStyle>
            <a:lvl1pPr>
              <a:defRPr sz="1974"/>
            </a:lvl1pPr>
            <a:lvl2pPr>
              <a:defRPr sz="1727"/>
            </a:lvl2pPr>
            <a:lvl3pPr>
              <a:defRPr sz="1480"/>
            </a:lvl3pPr>
            <a:lvl4pPr>
              <a:defRPr sz="1234"/>
            </a:lvl4pPr>
            <a:lvl5pPr>
              <a:defRPr sz="1234"/>
            </a:lvl5pPr>
            <a:lvl6pPr>
              <a:defRPr sz="1234"/>
            </a:lvl6pPr>
            <a:lvl7pPr>
              <a:defRPr sz="1234"/>
            </a:lvl7pPr>
            <a:lvl8pPr>
              <a:defRPr sz="1234"/>
            </a:lvl8pPr>
            <a:lvl9pPr>
              <a:defRPr sz="123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4441" y="4630223"/>
            <a:ext cx="7069537" cy="15135193"/>
          </a:xfrm>
        </p:spPr>
        <p:txBody>
          <a:bodyPr/>
          <a:lstStyle>
            <a:lvl1pPr marL="0" indent="0">
              <a:buNone/>
              <a:defRPr sz="864"/>
            </a:lvl1pPr>
            <a:lvl2pPr marL="281988" indent="0">
              <a:buNone/>
              <a:defRPr sz="740"/>
            </a:lvl2pPr>
            <a:lvl3pPr marL="563975" indent="0">
              <a:buNone/>
              <a:defRPr sz="617"/>
            </a:lvl3pPr>
            <a:lvl4pPr marL="845961" indent="0">
              <a:buNone/>
              <a:defRPr sz="555"/>
            </a:lvl4pPr>
            <a:lvl5pPr marL="1127948" indent="0">
              <a:buNone/>
              <a:defRPr sz="555"/>
            </a:lvl5pPr>
            <a:lvl6pPr marL="1409935" indent="0">
              <a:buNone/>
              <a:defRPr sz="555"/>
            </a:lvl6pPr>
            <a:lvl7pPr marL="1691921" indent="0">
              <a:buNone/>
              <a:defRPr sz="555"/>
            </a:lvl7pPr>
            <a:lvl8pPr marL="1973908" indent="0">
              <a:buNone/>
              <a:defRPr sz="555"/>
            </a:lvl8pPr>
            <a:lvl9pPr marL="2255896" indent="0">
              <a:buNone/>
              <a:defRPr sz="55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769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1878" y="15488623"/>
            <a:ext cx="12893040" cy="1828518"/>
          </a:xfrm>
        </p:spPr>
        <p:txBody>
          <a:bodyPr anchor="b"/>
          <a:lstStyle>
            <a:lvl1pPr algn="l">
              <a:defRPr sz="12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211878" y="1977055"/>
            <a:ext cx="12893040" cy="13275945"/>
          </a:xfrm>
        </p:spPr>
        <p:txBody>
          <a:bodyPr/>
          <a:lstStyle>
            <a:lvl1pPr marL="0" indent="0">
              <a:buNone/>
              <a:defRPr sz="1974"/>
            </a:lvl1pPr>
            <a:lvl2pPr marL="281988" indent="0">
              <a:buNone/>
              <a:defRPr sz="1727"/>
            </a:lvl2pPr>
            <a:lvl3pPr marL="563975" indent="0">
              <a:buNone/>
              <a:defRPr sz="1480"/>
            </a:lvl3pPr>
            <a:lvl4pPr marL="845961" indent="0">
              <a:buNone/>
              <a:defRPr sz="1234"/>
            </a:lvl4pPr>
            <a:lvl5pPr marL="1127948" indent="0">
              <a:buNone/>
              <a:defRPr sz="1234"/>
            </a:lvl5pPr>
            <a:lvl6pPr marL="1409935" indent="0">
              <a:buNone/>
              <a:defRPr sz="1234"/>
            </a:lvl6pPr>
            <a:lvl7pPr marL="1691921" indent="0">
              <a:buNone/>
              <a:defRPr sz="1234"/>
            </a:lvl7pPr>
            <a:lvl8pPr marL="1973908" indent="0">
              <a:buNone/>
              <a:defRPr sz="1234"/>
            </a:lvl8pPr>
            <a:lvl9pPr marL="2255896" indent="0">
              <a:buNone/>
              <a:defRPr sz="123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1878" y="17317140"/>
            <a:ext cx="12893040" cy="2596797"/>
          </a:xfrm>
        </p:spPr>
        <p:txBody>
          <a:bodyPr/>
          <a:lstStyle>
            <a:lvl1pPr marL="0" indent="0">
              <a:buNone/>
              <a:defRPr sz="864"/>
            </a:lvl1pPr>
            <a:lvl2pPr marL="281988" indent="0">
              <a:buNone/>
              <a:defRPr sz="740"/>
            </a:lvl2pPr>
            <a:lvl3pPr marL="563975" indent="0">
              <a:buNone/>
              <a:defRPr sz="617"/>
            </a:lvl3pPr>
            <a:lvl4pPr marL="845961" indent="0">
              <a:buNone/>
              <a:defRPr sz="555"/>
            </a:lvl4pPr>
            <a:lvl5pPr marL="1127948" indent="0">
              <a:buNone/>
              <a:defRPr sz="555"/>
            </a:lvl5pPr>
            <a:lvl6pPr marL="1409935" indent="0">
              <a:buNone/>
              <a:defRPr sz="555"/>
            </a:lvl6pPr>
            <a:lvl7pPr marL="1691921" indent="0">
              <a:buNone/>
              <a:defRPr sz="555"/>
            </a:lvl7pPr>
            <a:lvl8pPr marL="1973908" indent="0">
              <a:buNone/>
              <a:defRPr sz="555"/>
            </a:lvl8pPr>
            <a:lvl9pPr marL="2255896" indent="0">
              <a:buNone/>
              <a:defRPr sz="55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373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74429" y="886091"/>
            <a:ext cx="19339560" cy="3687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4429" y="5162889"/>
            <a:ext cx="19339560" cy="146025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74420" y="20508077"/>
            <a:ext cx="5013960" cy="11780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7DE55-82CE-8B41-B35C-6C156F5A00FB}" type="datetimeFigureOut">
              <a:rPr lang="en-US" smtClean="0"/>
              <a:pPr/>
              <a:t>4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341872" y="20508077"/>
            <a:ext cx="6804660" cy="11780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400020" y="20508077"/>
            <a:ext cx="5013960" cy="11780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645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81988" rtl="0" eaLnBrk="1" latinLnBrk="0" hangingPunct="1">
        <a:spcBef>
          <a:spcPct val="0"/>
        </a:spcBef>
        <a:buNone/>
        <a:defRPr sz="27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1490" indent="-211490" algn="l" defTabSz="281988" rtl="0" eaLnBrk="1" latinLnBrk="0" hangingPunct="1">
        <a:spcBef>
          <a:spcPct val="20000"/>
        </a:spcBef>
        <a:buFont typeface="Arial"/>
        <a:buChar char="•"/>
        <a:defRPr sz="1974" kern="1200">
          <a:solidFill>
            <a:schemeClr val="tx1"/>
          </a:solidFill>
          <a:latin typeface="+mn-lt"/>
          <a:ea typeface="+mn-ea"/>
          <a:cs typeface="+mn-cs"/>
        </a:defRPr>
      </a:lvl1pPr>
      <a:lvl2pPr marL="458228" indent="-176242" algn="l" defTabSz="281988" rtl="0" eaLnBrk="1" latinLnBrk="0" hangingPunct="1">
        <a:spcBef>
          <a:spcPct val="20000"/>
        </a:spcBef>
        <a:buFont typeface="Arial"/>
        <a:buChar char="–"/>
        <a:defRPr sz="1727" kern="1200">
          <a:solidFill>
            <a:schemeClr val="tx1"/>
          </a:solidFill>
          <a:latin typeface="+mn-lt"/>
          <a:ea typeface="+mn-ea"/>
          <a:cs typeface="+mn-cs"/>
        </a:defRPr>
      </a:lvl2pPr>
      <a:lvl3pPr marL="704967" indent="-140994" algn="l" defTabSz="281988" rtl="0" eaLnBrk="1" latinLnBrk="0" hangingPunct="1">
        <a:spcBef>
          <a:spcPct val="20000"/>
        </a:spcBef>
        <a:buFont typeface="Arial"/>
        <a:buChar char="•"/>
        <a:defRPr sz="1480" kern="1200">
          <a:solidFill>
            <a:schemeClr val="tx1"/>
          </a:solidFill>
          <a:latin typeface="+mn-lt"/>
          <a:ea typeface="+mn-ea"/>
          <a:cs typeface="+mn-cs"/>
        </a:defRPr>
      </a:lvl3pPr>
      <a:lvl4pPr marL="986954" indent="-140994" algn="l" defTabSz="281988" rtl="0" eaLnBrk="1" latinLnBrk="0" hangingPunct="1">
        <a:spcBef>
          <a:spcPct val="20000"/>
        </a:spcBef>
        <a:buFont typeface="Arial"/>
        <a:buChar char="–"/>
        <a:defRPr sz="1234" kern="1200">
          <a:solidFill>
            <a:schemeClr val="tx1"/>
          </a:solidFill>
          <a:latin typeface="+mn-lt"/>
          <a:ea typeface="+mn-ea"/>
          <a:cs typeface="+mn-cs"/>
        </a:defRPr>
      </a:lvl4pPr>
      <a:lvl5pPr marL="1268941" indent="-140994" algn="l" defTabSz="281988" rtl="0" eaLnBrk="1" latinLnBrk="0" hangingPunct="1">
        <a:spcBef>
          <a:spcPct val="20000"/>
        </a:spcBef>
        <a:buFont typeface="Arial"/>
        <a:buChar char="»"/>
        <a:defRPr sz="1234" kern="1200">
          <a:solidFill>
            <a:schemeClr val="tx1"/>
          </a:solidFill>
          <a:latin typeface="+mn-lt"/>
          <a:ea typeface="+mn-ea"/>
          <a:cs typeface="+mn-cs"/>
        </a:defRPr>
      </a:lvl5pPr>
      <a:lvl6pPr marL="1550928" indent="-140994" algn="l" defTabSz="281988" rtl="0" eaLnBrk="1" latinLnBrk="0" hangingPunct="1">
        <a:spcBef>
          <a:spcPct val="20000"/>
        </a:spcBef>
        <a:buFont typeface="Arial"/>
        <a:buChar char="•"/>
        <a:defRPr sz="1234" kern="1200">
          <a:solidFill>
            <a:schemeClr val="tx1"/>
          </a:solidFill>
          <a:latin typeface="+mn-lt"/>
          <a:ea typeface="+mn-ea"/>
          <a:cs typeface="+mn-cs"/>
        </a:defRPr>
      </a:lvl6pPr>
      <a:lvl7pPr marL="1832915" indent="-140994" algn="l" defTabSz="281988" rtl="0" eaLnBrk="1" latinLnBrk="0" hangingPunct="1">
        <a:spcBef>
          <a:spcPct val="20000"/>
        </a:spcBef>
        <a:buFont typeface="Arial"/>
        <a:buChar char="•"/>
        <a:defRPr sz="1234" kern="1200">
          <a:solidFill>
            <a:schemeClr val="tx1"/>
          </a:solidFill>
          <a:latin typeface="+mn-lt"/>
          <a:ea typeface="+mn-ea"/>
          <a:cs typeface="+mn-cs"/>
        </a:defRPr>
      </a:lvl7pPr>
      <a:lvl8pPr marL="2114902" indent="-140994" algn="l" defTabSz="281988" rtl="0" eaLnBrk="1" latinLnBrk="0" hangingPunct="1">
        <a:spcBef>
          <a:spcPct val="20000"/>
        </a:spcBef>
        <a:buFont typeface="Arial"/>
        <a:buChar char="•"/>
        <a:defRPr sz="1234" kern="1200">
          <a:solidFill>
            <a:schemeClr val="tx1"/>
          </a:solidFill>
          <a:latin typeface="+mn-lt"/>
          <a:ea typeface="+mn-ea"/>
          <a:cs typeface="+mn-cs"/>
        </a:defRPr>
      </a:lvl8pPr>
      <a:lvl9pPr marL="2396889" indent="-140994" algn="l" defTabSz="281988" rtl="0" eaLnBrk="1" latinLnBrk="0" hangingPunct="1">
        <a:spcBef>
          <a:spcPct val="20000"/>
        </a:spcBef>
        <a:buFont typeface="Arial"/>
        <a:buChar char="•"/>
        <a:defRPr sz="12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1pPr>
      <a:lvl2pPr marL="281988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2pPr>
      <a:lvl3pPr marL="563975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3pPr>
      <a:lvl4pPr marL="845961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4pPr>
      <a:lvl5pPr marL="1127948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5pPr>
      <a:lvl6pPr marL="1409935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6pPr>
      <a:lvl7pPr marL="1691921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7pPr>
      <a:lvl8pPr marL="1973908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8pPr>
      <a:lvl9pPr marL="2255896" algn="l" defTabSz="281988" rtl="0" eaLnBrk="1" latinLnBrk="0" hangingPunct="1">
        <a:defRPr sz="111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emf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1275469" y="20369436"/>
            <a:ext cx="181891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upplemental Figure 1.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Description of the phenotypic traits across1425 sorghum accessions used for the GWAS analysis. 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a, b and c)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plant height from Bako, Haramaya and combined</a:t>
            </a:r>
            <a:r>
              <a:rPr lang="en-US" altLang="ja-JP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, respectively,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d)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presence and absence of awns (1= awned and 2= awnless), 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e) 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anicle compactness and shape (1=loose erect, 2=loose drop, 3=compact elliptic (erect) and 4= compact oval or recurved), 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f) 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glume covering (1=grain uncovered, 2=25% of grain covered, 3=50% of grain covered, 4=75% of grain covered, 5=grain fully covered, 6=glumes longer than grain), 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g) 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ericarp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color (1=white, 2=yellow, 3=red, 4=brown and 5=buff),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(h) 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anicle exsertion score (1=panicle well exserted with10cm between ligule of flag leaf to panicle base, 2=2-10cm exsertion, 3=less than 2cm but ligule below the panicle base, 4=peduncle recurved but panicle is below the ligule and clearly exposed splitting the leaf sheath, 5=panicle covered by leaf sheath), 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</a:t>
            </a:r>
            <a:r>
              <a:rPr lang="en-US" sz="1400" b="1" dirty="0" err="1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i</a:t>
            </a:r>
            <a:r>
              <a:rPr lang="en-US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)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sterility group and </a:t>
            </a:r>
            <a:r>
              <a:rPr lang="en-US" altLang="ja-JP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j)</a:t>
            </a:r>
            <a:r>
              <a:rPr lang="en-US" altLang="ja-JP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smut damage score</a:t>
            </a:r>
            <a:r>
              <a:rPr lang="en-US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5850036-6245-5245-935F-D9CFB0E1C8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8233" y="829216"/>
            <a:ext cx="5888869" cy="553224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4F713BD-7E76-3C42-9679-2CF55697F4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8705" y="829217"/>
            <a:ext cx="5532241" cy="553224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ECB8C2D9-25E8-0F4E-B806-CD2EF16D18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932389" y="853312"/>
            <a:ext cx="5627167" cy="553224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2D5F5F9F-5B68-0248-AC41-38D1CD9A7C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26015" y="15288750"/>
            <a:ext cx="4792775" cy="4792775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D10C967B-6ECF-6C40-AE5D-16750A4F9E70}"/>
              </a:ext>
            </a:extLst>
          </p:cNvPr>
          <p:cNvSpPr txBox="1"/>
          <p:nvPr/>
        </p:nvSpPr>
        <p:spPr>
          <a:xfrm>
            <a:off x="6213964" y="1593918"/>
            <a:ext cx="465192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9728AA7-F986-B140-B356-61C088B85CAD}"/>
              </a:ext>
            </a:extLst>
          </p:cNvPr>
          <p:cNvSpPr txBox="1"/>
          <p:nvPr/>
        </p:nvSpPr>
        <p:spPr>
          <a:xfrm>
            <a:off x="6008683" y="15401498"/>
            <a:ext cx="410562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j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3F45596-3244-3042-A8D4-88E62C6B2BE6}"/>
              </a:ext>
            </a:extLst>
          </p:cNvPr>
          <p:cNvSpPr txBox="1"/>
          <p:nvPr/>
        </p:nvSpPr>
        <p:spPr>
          <a:xfrm>
            <a:off x="18548463" y="1557098"/>
            <a:ext cx="465192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83ED7A0-ECC1-5944-B6F0-A3E8F3E600C0}"/>
              </a:ext>
            </a:extLst>
          </p:cNvPr>
          <p:cNvSpPr txBox="1"/>
          <p:nvPr/>
        </p:nvSpPr>
        <p:spPr>
          <a:xfrm>
            <a:off x="12245789" y="1557098"/>
            <a:ext cx="476412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AB33DEA7-2B8F-8A48-A808-59905ED5577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78705" y="10989147"/>
            <a:ext cx="5530989" cy="4082454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2B649E66-AB18-2443-9CEC-6D92AFDD3DD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26015" y="10989255"/>
            <a:ext cx="5851087" cy="4093978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DD682E25-C468-3743-8BA4-17E736CB8B2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933641" y="10989148"/>
            <a:ext cx="5627167" cy="4082453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0DEE07CF-FF69-5543-86C8-928469356AD5}"/>
              </a:ext>
            </a:extLst>
          </p:cNvPr>
          <p:cNvSpPr txBox="1"/>
          <p:nvPr/>
        </p:nvSpPr>
        <p:spPr>
          <a:xfrm>
            <a:off x="18769550" y="11134668"/>
            <a:ext cx="401072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</a:t>
            </a:r>
            <a:r>
              <a:rPr lang="en-US" dirty="0" err="1"/>
              <a:t>i</a:t>
            </a:r>
            <a:r>
              <a:rPr lang="en-US" dirty="0"/>
              <a:t>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D742AB3-8803-F140-B2BE-EBE7ABB8A864}"/>
              </a:ext>
            </a:extLst>
          </p:cNvPr>
          <p:cNvSpPr txBox="1"/>
          <p:nvPr/>
        </p:nvSpPr>
        <p:spPr>
          <a:xfrm>
            <a:off x="12239377" y="11134667"/>
            <a:ext cx="476412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h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E3D91DE-C46D-8B4E-B014-F00BFF20EC2A}"/>
              </a:ext>
            </a:extLst>
          </p:cNvPr>
          <p:cNvSpPr txBox="1"/>
          <p:nvPr/>
        </p:nvSpPr>
        <p:spPr>
          <a:xfrm>
            <a:off x="6220536" y="11138657"/>
            <a:ext cx="463268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g)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E76E9297-5D5B-7142-A000-AF5E17F2313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932389" y="6561856"/>
            <a:ext cx="5627167" cy="3908919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2713FEF3-847F-AC46-9A76-D93D09B34C83}"/>
              </a:ext>
            </a:extLst>
          </p:cNvPr>
          <p:cNvSpPr txBox="1"/>
          <p:nvPr/>
        </p:nvSpPr>
        <p:spPr>
          <a:xfrm>
            <a:off x="18769550" y="6707459"/>
            <a:ext cx="424090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f)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2187489C-9978-BD4F-A880-09486FA6543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978705" y="6561856"/>
            <a:ext cx="5530989" cy="3908919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BAF95858-9CF2-F44F-BA27-4291CC379E36}"/>
              </a:ext>
            </a:extLst>
          </p:cNvPr>
          <p:cNvSpPr txBox="1"/>
          <p:nvPr/>
        </p:nvSpPr>
        <p:spPr>
          <a:xfrm>
            <a:off x="12245789" y="6693142"/>
            <a:ext cx="470000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e)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F73A266A-804C-3245-9DD9-976A8A94FAC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88233" y="6561856"/>
            <a:ext cx="5888869" cy="3908918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3E149A6E-880C-CB4B-A7B5-94600A42E05A}"/>
              </a:ext>
            </a:extLst>
          </p:cNvPr>
          <p:cNvSpPr txBox="1"/>
          <p:nvPr/>
        </p:nvSpPr>
        <p:spPr>
          <a:xfrm>
            <a:off x="6207392" y="6707459"/>
            <a:ext cx="476412" cy="400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1403127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5</TotalTime>
  <Words>260</Words>
  <Application>Microsoft Macintosh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IB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luneh Tamiru Oli</dc:creator>
  <cp:lastModifiedBy>Gezahegn Girma</cp:lastModifiedBy>
  <cp:revision>64</cp:revision>
  <cp:lastPrinted>2014-10-29T04:25:43Z</cp:lastPrinted>
  <dcterms:created xsi:type="dcterms:W3CDTF">2015-05-11T20:03:38Z</dcterms:created>
  <dcterms:modified xsi:type="dcterms:W3CDTF">2019-04-16T20:19:53Z</dcterms:modified>
</cp:coreProperties>
</file>